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67AD14-8DC7-4CE5-A601-B32B3236E4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8A215-977C-4990-8E07-DCDCB71339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5624A-AAB5-4693-AFE5-2A2A3CEA573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287A5-8471-4727-A252-44158E8BF3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2033B6-F728-4734-BCE6-F7D36B273C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8D6CAB-5DA1-40B2-BE77-EA54E75F32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BCC92-0E85-4B53-9F4A-CCB606A721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DF32D-DFAC-4F25-B703-8CC557AAA0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4FFA7-BCF5-48CC-ACB8-D97D125563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51AB0-CE15-44AC-B511-B0E06DE908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35CC3-F03A-4F41-9466-F0168AD37D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C9213-ECCF-4C17-B569-3FA702A3F0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162904-9F31-4750-8AB8-353C354FDDCB}" type="slidenum"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295280" y="1308240"/>
            <a:ext cx="6400800" cy="28605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190520" y="5132520"/>
            <a:ext cx="6732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There is a reasonable correlation of the seroreactivity profile of thymoma patient M13 to the profiles of 4/9 LOMG and to 10/15 EOMG patients (marked with arrows)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(1) Thymoma patient M13 showing self-correlatio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1219320" y="812880"/>
            <a:ext cx="7086600" cy="3733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1190520" y="4444920"/>
            <a:ext cx="6858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orrelation of seroreactivity profiles of M13 (thymoma patient) with the other early onset (EOMG) and late onset myasthenia gravis (LOMG) patient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40320" y="44280"/>
            <a:ext cx="235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14T12:33:18Z</dcterms:created>
  <dc:creator>Nicole Ludwig</dc:creator>
  <dc:description/>
  <dc:language>en-US</dc:language>
  <cp:lastModifiedBy>RUPRECHK</cp:lastModifiedBy>
  <dcterms:modified xsi:type="dcterms:W3CDTF">2012-12-21T09:02:06Z</dcterms:modified>
  <cp:revision>3</cp:revision>
  <dc:subject/>
  <dc:title>PowerPoint-Präsentation</dc:title>
</cp:coreProperties>
</file>